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3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39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009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348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145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170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383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837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957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106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475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058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752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253D5-A3E2-4098-BEBE-CA6D34BA86D0}" type="datetimeFigureOut">
              <a:rPr lang="en-US" smtClean="0"/>
              <a:t>9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597D5-58CF-49EF-977C-AE46EC3E4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514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4" Type="http://schemas.microsoft.com/office/2007/relationships/hdphoto" Target="../media/hdphoto2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microsoft.com/office/2007/relationships/hdphoto" Target="../media/hdphoto3.wdp"/><Relationship Id="rId7" Type="http://schemas.microsoft.com/office/2007/relationships/hdphoto" Target="../media/hdphoto4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jpeg"/><Relationship Id="rId4" Type="http://schemas.openxmlformats.org/officeDocument/2006/relationships/image" Target="../media/image7.jpeg"/><Relationship Id="rId9" Type="http://schemas.microsoft.com/office/2007/relationships/hdphoto" Target="../media/hdphoto5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7.wdp"/><Relationship Id="rId5" Type="http://schemas.openxmlformats.org/officeDocument/2006/relationships/image" Target="../media/image13.png"/><Relationship Id="rId4" Type="http://schemas.microsoft.com/office/2007/relationships/hdphoto" Target="../media/hdphoto6.wdp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8.wdp"/><Relationship Id="rId7" Type="http://schemas.microsoft.com/office/2007/relationships/hdphoto" Target="../media/hdphoto10.wdp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microsoft.com/office/2007/relationships/hdphoto" Target="../media/hdphoto9.wdp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/>
          <p:cNvSpPr txBox="1"/>
          <p:nvPr/>
        </p:nvSpPr>
        <p:spPr>
          <a:xfrm>
            <a:off x="633929" y="361010"/>
            <a:ext cx="2611830" cy="3831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1</a:t>
            </a:r>
            <a:endParaRPr lang="en-US" dirty="0"/>
          </a:p>
        </p:txBody>
      </p:sp>
      <p:grpSp>
        <p:nvGrpSpPr>
          <p:cNvPr id="34" name="Group 33"/>
          <p:cNvGrpSpPr/>
          <p:nvPr/>
        </p:nvGrpSpPr>
        <p:grpSpPr>
          <a:xfrm>
            <a:off x="2653833" y="1346982"/>
            <a:ext cx="3375280" cy="3685169"/>
            <a:chOff x="2668886" y="1303602"/>
            <a:chExt cx="3375280" cy="3685169"/>
          </a:xfrm>
        </p:grpSpPr>
        <p:grpSp>
          <p:nvGrpSpPr>
            <p:cNvPr id="10" name="Group 9"/>
            <p:cNvGrpSpPr/>
            <p:nvPr/>
          </p:nvGrpSpPr>
          <p:grpSpPr>
            <a:xfrm>
              <a:off x="2668886" y="1303602"/>
              <a:ext cx="3375280" cy="3685169"/>
              <a:chOff x="1298319" y="493605"/>
              <a:chExt cx="3375280" cy="3685169"/>
            </a:xfrm>
          </p:grpSpPr>
          <p:pic>
            <p:nvPicPr>
              <p:cNvPr id="36" name="Picture 35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" t="35628" r="1626" b="22916"/>
              <a:stretch/>
            </p:blipFill>
            <p:spPr>
              <a:xfrm>
                <a:off x="1298319" y="2558980"/>
                <a:ext cx="2272195" cy="1619794"/>
              </a:xfrm>
              <a:prstGeom prst="rect">
                <a:avLst/>
              </a:prstGeom>
            </p:spPr>
          </p:pic>
          <p:pic>
            <p:nvPicPr>
              <p:cNvPr id="37" name="Picture 36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22" t="36146" r="-619" b="47463"/>
              <a:stretch/>
            </p:blipFill>
            <p:spPr>
              <a:xfrm>
                <a:off x="1301200" y="1809448"/>
                <a:ext cx="2230610" cy="638628"/>
              </a:xfrm>
              <a:prstGeom prst="rect">
                <a:avLst/>
              </a:prstGeom>
            </p:spPr>
          </p:pic>
          <p:sp>
            <p:nvSpPr>
              <p:cNvPr id="2" name="Rectangle 1"/>
              <p:cNvSpPr/>
              <p:nvPr/>
            </p:nvSpPr>
            <p:spPr>
              <a:xfrm>
                <a:off x="1298319" y="2077997"/>
                <a:ext cx="2180271" cy="244176"/>
              </a:xfrm>
              <a:prstGeom prst="rect">
                <a:avLst/>
              </a:prstGeom>
              <a:noFill/>
              <a:ln>
                <a:solidFill>
                  <a:srgbClr val="FFFF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1299993" y="2773002"/>
                <a:ext cx="2178597" cy="1287538"/>
              </a:xfrm>
              <a:prstGeom prst="rect">
                <a:avLst/>
              </a:prstGeom>
              <a:noFill/>
              <a:ln>
                <a:solidFill>
                  <a:srgbClr val="FFFF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7972669">
                <a:off x="950928" y="1028816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Ms.brn</a:t>
                </a:r>
                <a:r>
                  <a:rPr lang="en-US" dirty="0" smtClean="0"/>
                  <a:t> </a:t>
                </a:r>
                <a:r>
                  <a:rPr lang="en-US" dirty="0" err="1" smtClean="0"/>
                  <a:t>extr</a:t>
                </a:r>
                <a:endParaRPr lang="en-US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7949163">
                <a:off x="1158725" y="1030084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Hu.brn</a:t>
                </a:r>
                <a:r>
                  <a:rPr lang="en-US" dirty="0" smtClean="0"/>
                  <a:t> </a:t>
                </a:r>
                <a:r>
                  <a:rPr lang="en-US" dirty="0" err="1" smtClean="0"/>
                  <a:t>extr</a:t>
                </a:r>
                <a:endParaRPr lang="en-US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7935799">
                <a:off x="1406022" y="1017969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Alz.brn</a:t>
                </a:r>
                <a:r>
                  <a:rPr lang="en-US" dirty="0" smtClean="0"/>
                  <a:t> </a:t>
                </a:r>
                <a:r>
                  <a:rPr lang="en-US" dirty="0" err="1" smtClean="0"/>
                  <a:t>extr</a:t>
                </a:r>
                <a:endParaRPr lang="en-US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7950603">
                <a:off x="1611384" y="1047838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 ladder</a:t>
                </a:r>
                <a:endParaRPr lang="en-US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7932914">
                <a:off x="1801989" y="1020510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arker</a:t>
                </a:r>
                <a:endParaRPr lang="en-US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7932914">
                <a:off x="2017946" y="1026690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OVCAR-4</a:t>
                </a:r>
                <a:endParaRPr lang="en-US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7932914">
                <a:off x="2263342" y="1042752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OVCAR4-PR2</a:t>
                </a:r>
                <a:endParaRPr lang="en-US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7932914">
                <a:off x="2489654" y="1048464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STOSE</a:t>
                </a:r>
                <a:endParaRPr lang="en-US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7932914">
                <a:off x="2709876" y="1048464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STOSE-PR25</a:t>
                </a:r>
                <a:endParaRPr lang="en-US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7932914">
                <a:off x="2958277" y="1040651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STOSE-PR50</a:t>
                </a:r>
                <a:endParaRPr lang="en-US" dirty="0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3478590" y="2015419"/>
                <a:ext cx="11950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vinculin</a:t>
                </a:r>
                <a:endParaRPr lang="en-US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708903" y="3154438"/>
                <a:ext cx="50507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</a:t>
                </a:r>
                <a:endParaRPr lang="en-US" dirty="0"/>
              </a:p>
            </p:txBody>
          </p:sp>
        </p:grpSp>
        <p:sp>
          <p:nvSpPr>
            <p:cNvPr id="22" name="TextBox 21"/>
            <p:cNvSpPr txBox="1"/>
            <p:nvPr/>
          </p:nvSpPr>
          <p:spPr>
            <a:xfrm>
              <a:off x="3444239" y="2933136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0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459479" y="3527496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7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450515" y="3818846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455002" y="4110197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4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459484" y="4298452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3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444238" y="4724722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6331755" y="1630941"/>
            <a:ext cx="3281112" cy="3476072"/>
            <a:chOff x="6331755" y="1630941"/>
            <a:chExt cx="3281112" cy="3476072"/>
          </a:xfrm>
        </p:grpSpPr>
        <p:grpSp>
          <p:nvGrpSpPr>
            <p:cNvPr id="21" name="Group 20"/>
            <p:cNvGrpSpPr/>
            <p:nvPr/>
          </p:nvGrpSpPr>
          <p:grpSpPr>
            <a:xfrm>
              <a:off x="6696523" y="1630941"/>
              <a:ext cx="2916344" cy="3476072"/>
              <a:chOff x="5206387" y="710070"/>
              <a:chExt cx="2916344" cy="3476072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5206387" y="2035125"/>
                <a:ext cx="2342604" cy="2151017"/>
                <a:chOff x="2481944" y="640079"/>
                <a:chExt cx="2342604" cy="2151017"/>
              </a:xfrm>
            </p:grpSpPr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7000"/>
                          </a14:imgEffect>
                          <a14:imgEffect>
                            <a14:brightnessContrast contrast="-53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-901" t="190" r="345" b="-1276"/>
                <a:stretch/>
              </p:blipFill>
              <p:spPr>
                <a:xfrm>
                  <a:off x="2481944" y="640079"/>
                  <a:ext cx="2342604" cy="2151017"/>
                </a:xfrm>
                <a:prstGeom prst="rect">
                  <a:avLst/>
                </a:prstGeom>
              </p:spPr>
            </p:pic>
            <p:sp>
              <p:nvSpPr>
                <p:cNvPr id="8" name="Rectangle 7"/>
                <p:cNvSpPr/>
                <p:nvPr/>
              </p:nvSpPr>
              <p:spPr>
                <a:xfrm>
                  <a:off x="2550606" y="741554"/>
                  <a:ext cx="2131926" cy="161314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23" name="TextBox 22"/>
              <p:cNvSpPr txBox="1"/>
              <p:nvPr/>
            </p:nvSpPr>
            <p:spPr>
              <a:xfrm>
                <a:off x="7617653" y="2917587"/>
                <a:ext cx="50507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</a:t>
                </a:r>
                <a:endParaRPr lang="en-US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7932914">
                <a:off x="4886275" y="1255156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arker</a:t>
                </a:r>
                <a:endParaRPr lang="en-US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7972669">
                <a:off x="5215712" y="1234434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Ms.brn</a:t>
                </a:r>
                <a:r>
                  <a:rPr lang="en-US" dirty="0" smtClean="0"/>
                  <a:t> </a:t>
                </a:r>
                <a:r>
                  <a:rPr lang="en-US" dirty="0" err="1" smtClean="0"/>
                  <a:t>extr</a:t>
                </a:r>
                <a:endParaRPr lang="en-US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7950603">
                <a:off x="5460087" y="1263132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 ladder</a:t>
                </a:r>
                <a:endParaRPr lang="en-US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7932914">
                <a:off x="6543978" y="1241984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OVCAR-4</a:t>
                </a:r>
                <a:endParaRPr lang="en-US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7932914">
                <a:off x="6789374" y="1258046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OVCAR4-PR2</a:t>
                </a:r>
                <a:endParaRPr lang="en-US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7932914">
                <a:off x="6040899" y="1263758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STOSE-PR25</a:t>
                </a:r>
                <a:endParaRPr lang="en-US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7932914">
                <a:off x="6289300" y="1255945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STOSE-PR50</a:t>
                </a:r>
                <a:endParaRPr lang="en-US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7932914">
                <a:off x="5781977" y="1258920"/>
                <a:ext cx="1423195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STOSE</a:t>
                </a:r>
                <a:endParaRPr lang="en-US" dirty="0"/>
              </a:p>
            </p:txBody>
          </p:sp>
        </p:grpSp>
        <p:sp>
          <p:nvSpPr>
            <p:cNvPr id="42" name="TextBox 41"/>
            <p:cNvSpPr txBox="1"/>
            <p:nvPr/>
          </p:nvSpPr>
          <p:spPr>
            <a:xfrm>
              <a:off x="6331755" y="3092588"/>
              <a:ext cx="4366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381176" y="3189567"/>
              <a:ext cx="4032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373273" y="3283006"/>
              <a:ext cx="4118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357123" y="3733077"/>
              <a:ext cx="4272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6364676" y="4003497"/>
              <a:ext cx="4374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343923" y="4299880"/>
              <a:ext cx="4762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363354" y="4471522"/>
              <a:ext cx="4374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331760" y="2989497"/>
              <a:ext cx="4366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6361609" y="3495519"/>
              <a:ext cx="4272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769561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77797" y="314196"/>
            <a:ext cx="2611830" cy="3831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2</a:t>
            </a:r>
            <a:endParaRPr lang="en-US" dirty="0"/>
          </a:p>
        </p:txBody>
      </p:sp>
      <p:grpSp>
        <p:nvGrpSpPr>
          <p:cNvPr id="44" name="Group 43"/>
          <p:cNvGrpSpPr/>
          <p:nvPr/>
        </p:nvGrpSpPr>
        <p:grpSpPr>
          <a:xfrm>
            <a:off x="2986813" y="365153"/>
            <a:ext cx="5760224" cy="5495758"/>
            <a:chOff x="2986813" y="365153"/>
            <a:chExt cx="5760224" cy="5495758"/>
          </a:xfrm>
        </p:grpSpPr>
        <p:grpSp>
          <p:nvGrpSpPr>
            <p:cNvPr id="27" name="Group 26"/>
            <p:cNvGrpSpPr/>
            <p:nvPr/>
          </p:nvGrpSpPr>
          <p:grpSpPr>
            <a:xfrm>
              <a:off x="2986813" y="365153"/>
              <a:ext cx="5760224" cy="5495758"/>
              <a:chOff x="1216796" y="-331533"/>
              <a:chExt cx="5760224" cy="5495758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1216796" y="1763150"/>
                <a:ext cx="1337983" cy="2152997"/>
                <a:chOff x="1085222" y="909040"/>
                <a:chExt cx="1337983" cy="2152997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938" t="24383" r="45158" b="21455"/>
                <a:stretch/>
              </p:blipFill>
              <p:spPr>
                <a:xfrm flipH="1">
                  <a:off x="1085222" y="909040"/>
                  <a:ext cx="1337983" cy="2152997"/>
                </a:xfrm>
                <a:prstGeom prst="rect">
                  <a:avLst/>
                </a:prstGeom>
              </p:spPr>
            </p:pic>
            <p:sp>
              <p:nvSpPr>
                <p:cNvPr id="5" name="Rectangle 4"/>
                <p:cNvSpPr/>
                <p:nvPr/>
              </p:nvSpPr>
              <p:spPr>
                <a:xfrm>
                  <a:off x="1175657" y="1266092"/>
                  <a:ext cx="914400" cy="1517301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2821578" y="1833823"/>
                <a:ext cx="3857897" cy="2090058"/>
                <a:chOff x="2942158" y="909040"/>
                <a:chExt cx="3857897" cy="2090058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sharpenSoften amount="33000"/>
                          </a14:imgEffect>
                          <a14:imgEffect>
                            <a14:brightnessContrast bright="7000" contrast="1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384" t="31102" r="-683" b="29814"/>
                <a:stretch/>
              </p:blipFill>
              <p:spPr>
                <a:xfrm>
                  <a:off x="2942158" y="909040"/>
                  <a:ext cx="3857897" cy="2090058"/>
                </a:xfrm>
                <a:prstGeom prst="rect">
                  <a:avLst/>
                </a:prstGeom>
              </p:spPr>
            </p:pic>
            <p:sp>
              <p:nvSpPr>
                <p:cNvPr id="6" name="Rectangle 5"/>
                <p:cNvSpPr/>
                <p:nvPr/>
              </p:nvSpPr>
              <p:spPr>
                <a:xfrm>
                  <a:off x="4210261" y="1195754"/>
                  <a:ext cx="620653" cy="1497204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" name="Rectangle 6"/>
                <p:cNvSpPr/>
                <p:nvPr/>
              </p:nvSpPr>
              <p:spPr>
                <a:xfrm>
                  <a:off x="4865082" y="1207479"/>
                  <a:ext cx="1776878" cy="1497204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0" name="TextBox 9"/>
              <p:cNvSpPr txBox="1"/>
              <p:nvPr/>
            </p:nvSpPr>
            <p:spPr>
              <a:xfrm rot="18646095">
                <a:off x="862149" y="643827"/>
                <a:ext cx="2325188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arker</a:t>
                </a:r>
                <a:endParaRPr lang="en-US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8646095">
                <a:off x="1059037" y="682226"/>
                <a:ext cx="2325188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Hu.brain</a:t>
                </a:r>
                <a:r>
                  <a:rPr lang="en-US" dirty="0" smtClean="0"/>
                  <a:t> extract</a:t>
                </a:r>
                <a:endParaRPr lang="en-US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8646095">
                <a:off x="1313601" y="663026"/>
                <a:ext cx="2325188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Alz.brain</a:t>
                </a:r>
                <a:r>
                  <a:rPr lang="en-US" dirty="0" smtClean="0"/>
                  <a:t> extract</a:t>
                </a:r>
                <a:endParaRPr lang="en-US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8646095">
                <a:off x="1535671" y="693500"/>
                <a:ext cx="2325188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Ms.brain</a:t>
                </a:r>
                <a:r>
                  <a:rPr lang="en-US" dirty="0" smtClean="0"/>
                  <a:t> extract</a:t>
                </a:r>
                <a:endParaRPr lang="en-US" dirty="0"/>
              </a:p>
            </p:txBody>
          </p:sp>
          <p:sp>
            <p:nvSpPr>
              <p:cNvPr id="14" name="Left Bracket 13"/>
              <p:cNvSpPr/>
              <p:nvPr/>
            </p:nvSpPr>
            <p:spPr>
              <a:xfrm rot="16200000">
                <a:off x="2614720" y="3060876"/>
                <a:ext cx="896983" cy="3294247"/>
              </a:xfrm>
              <a:prstGeom prst="leftBracket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301862" y="4531067"/>
                <a:ext cx="137761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 ab-3</a:t>
                </a:r>
                <a:endParaRPr lang="en-US" dirty="0"/>
              </a:p>
            </p:txBody>
          </p:sp>
          <p:sp>
            <p:nvSpPr>
              <p:cNvPr id="16" name="Left Bracket 15"/>
              <p:cNvSpPr/>
              <p:nvPr/>
            </p:nvSpPr>
            <p:spPr>
              <a:xfrm rot="16200000">
                <a:off x="5328374" y="3971219"/>
                <a:ext cx="896983" cy="1489029"/>
              </a:xfrm>
              <a:prstGeom prst="leftBracket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858734" y="4523333"/>
                <a:ext cx="240895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 phosphoSer396</a:t>
                </a:r>
                <a:endParaRPr lang="en-US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8646095">
                <a:off x="4349943" y="761391"/>
                <a:ext cx="2325188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arker</a:t>
                </a:r>
                <a:endParaRPr lang="en-US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8646095">
                <a:off x="4851634" y="799790"/>
                <a:ext cx="2325188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Hu.brain</a:t>
                </a:r>
                <a:r>
                  <a:rPr lang="en-US" dirty="0" smtClean="0"/>
                  <a:t> extract</a:t>
                </a:r>
                <a:endParaRPr lang="en-US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8646095">
                <a:off x="5088784" y="780590"/>
                <a:ext cx="2325188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Alz.brain</a:t>
                </a:r>
                <a:r>
                  <a:rPr lang="en-US" dirty="0" smtClean="0"/>
                  <a:t> extract</a:t>
                </a:r>
                <a:endParaRPr lang="en-US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8646095">
                <a:off x="4600791" y="770586"/>
                <a:ext cx="2325188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Ms.brain</a:t>
                </a:r>
                <a:r>
                  <a:rPr lang="en-US" dirty="0" smtClean="0"/>
                  <a:t> extract</a:t>
                </a:r>
                <a:endParaRPr lang="en-US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8646095">
                <a:off x="5439608" y="1029524"/>
                <a:ext cx="1633296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 ladder</a:t>
                </a:r>
                <a:endParaRPr lang="en-US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8646095">
                <a:off x="5661676" y="1051289"/>
                <a:ext cx="1633296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OVCAR-4</a:t>
                </a:r>
                <a:endParaRPr lang="en-US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8646095">
                <a:off x="3838609" y="1072356"/>
                <a:ext cx="1633296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OVCAR-4</a:t>
                </a:r>
                <a:endParaRPr lang="en-US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8646095">
                <a:off x="5973138" y="1048726"/>
                <a:ext cx="1633296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OVCAR4-PR2</a:t>
                </a:r>
                <a:endParaRPr lang="en-US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8646095">
                <a:off x="4139641" y="1053720"/>
                <a:ext cx="1633296" cy="374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OVCAR4-PR2</a:t>
                </a:r>
                <a:endParaRPr lang="en-US" dirty="0"/>
              </a:p>
            </p:txBody>
          </p:sp>
        </p:grpSp>
        <p:sp>
          <p:nvSpPr>
            <p:cNvPr id="28" name="TextBox 27"/>
            <p:cNvSpPr txBox="1"/>
            <p:nvPr/>
          </p:nvSpPr>
          <p:spPr>
            <a:xfrm>
              <a:off x="3034895" y="3061045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0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029302" y="3248505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7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025179" y="3496484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025178" y="3676035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4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025178" y="3822947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3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018465" y="4119383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031356" y="2937680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034895" y="2813580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493188" y="3002421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0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6487595" y="3189881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7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483472" y="3408553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483471" y="3599827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4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483471" y="3770182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3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476758" y="4119376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489649" y="2879056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493188" y="2719786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325832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1436" y="283139"/>
            <a:ext cx="2611830" cy="3831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3</a:t>
            </a:r>
            <a:endParaRPr lang="en-US" dirty="0"/>
          </a:p>
        </p:txBody>
      </p:sp>
      <p:grpSp>
        <p:nvGrpSpPr>
          <p:cNvPr id="62" name="Group 61"/>
          <p:cNvGrpSpPr/>
          <p:nvPr/>
        </p:nvGrpSpPr>
        <p:grpSpPr>
          <a:xfrm>
            <a:off x="1889425" y="-726503"/>
            <a:ext cx="4938431" cy="4382541"/>
            <a:chOff x="1889425" y="-726503"/>
            <a:chExt cx="4938431" cy="4382541"/>
          </a:xfrm>
        </p:grpSpPr>
        <p:grpSp>
          <p:nvGrpSpPr>
            <p:cNvPr id="24" name="Group 23"/>
            <p:cNvGrpSpPr/>
            <p:nvPr/>
          </p:nvGrpSpPr>
          <p:grpSpPr>
            <a:xfrm>
              <a:off x="1889425" y="-726503"/>
              <a:ext cx="4938431" cy="4382541"/>
              <a:chOff x="513135" y="411696"/>
              <a:chExt cx="4938431" cy="4382541"/>
            </a:xfrm>
          </p:grpSpPr>
          <p:sp>
            <p:nvSpPr>
              <p:cNvPr id="18" name="TextBox 17"/>
              <p:cNvSpPr txBox="1"/>
              <p:nvPr/>
            </p:nvSpPr>
            <p:spPr>
              <a:xfrm rot="17778649">
                <a:off x="399495" y="1166886"/>
                <a:ext cx="187971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 ladder</a:t>
                </a:r>
                <a:endParaRPr lang="en-US" dirty="0"/>
              </a:p>
            </p:txBody>
          </p:sp>
          <p:grpSp>
            <p:nvGrpSpPr>
              <p:cNvPr id="23" name="Group 22"/>
              <p:cNvGrpSpPr/>
              <p:nvPr/>
            </p:nvGrpSpPr>
            <p:grpSpPr>
              <a:xfrm>
                <a:off x="513135" y="1650776"/>
                <a:ext cx="4938431" cy="3143461"/>
                <a:chOff x="513135" y="1650776"/>
                <a:chExt cx="4938431" cy="3143461"/>
              </a:xfrm>
            </p:grpSpPr>
            <p:grpSp>
              <p:nvGrpSpPr>
                <p:cNvPr id="15" name="Group 14"/>
                <p:cNvGrpSpPr/>
                <p:nvPr/>
              </p:nvGrpSpPr>
              <p:grpSpPr>
                <a:xfrm>
                  <a:off x="513135" y="2225209"/>
                  <a:ext cx="3431177" cy="2569028"/>
                  <a:chOff x="644434" y="853440"/>
                  <a:chExt cx="3431177" cy="2569028"/>
                </a:xfrm>
              </p:grpSpPr>
              <p:pic>
                <p:nvPicPr>
                  <p:cNvPr id="6" name="Picture 5"/>
                  <p:cNvPicPr>
                    <a:picLocks noChangeAspect="1"/>
                  </p:cNvPicPr>
                  <p:nvPr/>
                </p:nvPicPr>
                <p:blipFill rotWithShape="1">
                  <a:blip r:embed="rId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brightnessContrast bright="9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818" t="40252" r="466" b="14486"/>
                  <a:stretch/>
                </p:blipFill>
                <p:spPr>
                  <a:xfrm>
                    <a:off x="644434" y="1619794"/>
                    <a:ext cx="3370217" cy="1802674"/>
                  </a:xfrm>
                  <a:prstGeom prst="rect">
                    <a:avLst/>
                  </a:prstGeom>
                </p:spPr>
              </p:pic>
              <p:pic>
                <p:nvPicPr>
                  <p:cNvPr id="7" name="Picture 6"/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4439" t="40939" r="987" b="38993"/>
                  <a:stretch/>
                </p:blipFill>
                <p:spPr>
                  <a:xfrm>
                    <a:off x="975360" y="853440"/>
                    <a:ext cx="3100251" cy="644434"/>
                  </a:xfrm>
                  <a:prstGeom prst="rect">
                    <a:avLst/>
                  </a:prstGeom>
                </p:spPr>
              </p:pic>
              <p:sp>
                <p:nvSpPr>
                  <p:cNvPr id="8" name="Rectangle 7"/>
                  <p:cNvSpPr/>
                  <p:nvPr/>
                </p:nvSpPr>
                <p:spPr>
                  <a:xfrm>
                    <a:off x="743578" y="1798656"/>
                    <a:ext cx="1929284" cy="1256044"/>
                  </a:xfrm>
                  <a:prstGeom prst="rect">
                    <a:avLst/>
                  </a:prstGeom>
                  <a:noFill/>
                  <a:ln>
                    <a:solidFill>
                      <a:srgbClr val="FFFF00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9" name="Rectangle 8"/>
                  <p:cNvSpPr/>
                  <p:nvPr/>
                </p:nvSpPr>
                <p:spPr>
                  <a:xfrm>
                    <a:off x="1286189" y="984738"/>
                    <a:ext cx="1386673" cy="251209"/>
                  </a:xfrm>
                  <a:prstGeom prst="rect">
                    <a:avLst/>
                  </a:prstGeom>
                  <a:noFill/>
                  <a:ln>
                    <a:solidFill>
                      <a:srgbClr val="FFFF00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7" name="TextBox 16"/>
                <p:cNvSpPr txBox="1"/>
                <p:nvPr/>
              </p:nvSpPr>
              <p:spPr>
                <a:xfrm rot="16200000">
                  <a:off x="14848" y="2171840"/>
                  <a:ext cx="141145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mtClean="0"/>
                    <a:t>Marker</a:t>
                  </a:r>
                  <a:endParaRPr lang="en-US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1204685" y="1895845"/>
                  <a:ext cx="287625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0  3.4  6.7  10 µM TRx0237</a:t>
                  </a:r>
                  <a:endParaRPr lang="en-US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1339351" y="1650776"/>
                  <a:ext cx="138442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OVCAR-4</a:t>
                  </a:r>
                  <a:endParaRPr lang="en-US" dirty="0"/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3982496" y="2356506"/>
                  <a:ext cx="1469070" cy="3779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vinculin</a:t>
                  </a:r>
                  <a:endParaRPr lang="en-US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3944312" y="3345264"/>
                  <a:ext cx="932488" cy="3697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tau</a:t>
                  </a:r>
                  <a:endParaRPr lang="en-US" dirty="0"/>
                </a:p>
              </p:txBody>
            </p:sp>
          </p:grpSp>
        </p:grpSp>
        <p:sp>
          <p:nvSpPr>
            <p:cNvPr id="44" name="TextBox 43"/>
            <p:cNvSpPr txBox="1"/>
            <p:nvPr/>
          </p:nvSpPr>
          <p:spPr>
            <a:xfrm>
              <a:off x="2160425" y="1240319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0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007128" y="1972433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7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007128" y="2219401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007128" y="2435342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4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997149" y="2641441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3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997149" y="3072826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160425" y="1150869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161137" y="1075920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4387370" y="3606080"/>
            <a:ext cx="4761280" cy="3098686"/>
            <a:chOff x="4387370" y="3606080"/>
            <a:chExt cx="4761280" cy="3098686"/>
          </a:xfrm>
        </p:grpSpPr>
        <p:grpSp>
          <p:nvGrpSpPr>
            <p:cNvPr id="43" name="Group 42"/>
            <p:cNvGrpSpPr/>
            <p:nvPr/>
          </p:nvGrpSpPr>
          <p:grpSpPr>
            <a:xfrm>
              <a:off x="4387370" y="3606080"/>
              <a:ext cx="4761280" cy="3098686"/>
              <a:chOff x="2066576" y="3647109"/>
              <a:chExt cx="4761280" cy="3098686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2066576" y="4873452"/>
                <a:ext cx="3230880" cy="1872343"/>
                <a:chOff x="975360" y="3980488"/>
                <a:chExt cx="3230880" cy="1872343"/>
              </a:xfrm>
            </p:grpSpPr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-860" t="19126" r="-117" b="33697"/>
                <a:stretch/>
              </p:blipFill>
              <p:spPr>
                <a:xfrm>
                  <a:off x="975360" y="3980488"/>
                  <a:ext cx="3230880" cy="1872343"/>
                </a:xfrm>
                <a:prstGeom prst="rect">
                  <a:avLst/>
                </a:prstGeom>
              </p:spPr>
            </p:pic>
            <p:sp>
              <p:nvSpPr>
                <p:cNvPr id="12" name="Rectangle 11"/>
                <p:cNvSpPr/>
                <p:nvPr/>
              </p:nvSpPr>
              <p:spPr>
                <a:xfrm>
                  <a:off x="1135464" y="4431323"/>
                  <a:ext cx="1668026" cy="1145512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" name="Rectangle 12"/>
                <p:cNvSpPr/>
                <p:nvPr/>
              </p:nvSpPr>
              <p:spPr>
                <a:xfrm>
                  <a:off x="1567543" y="4069582"/>
                  <a:ext cx="1235947" cy="291403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34" name="TextBox 33"/>
              <p:cNvSpPr txBox="1"/>
              <p:nvPr/>
            </p:nvSpPr>
            <p:spPr>
              <a:xfrm rot="16200000">
                <a:off x="1673203" y="4104536"/>
                <a:ext cx="12841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 ladder</a:t>
                </a:r>
                <a:endParaRPr lang="en-US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6200000">
                <a:off x="1986667" y="4233890"/>
                <a:ext cx="10719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Marker</a:t>
                </a:r>
                <a:endParaRPr lang="en-US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8188627">
                <a:off x="2529387" y="4283704"/>
                <a:ext cx="9392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CTRLsi</a:t>
                </a:r>
                <a:endParaRPr lang="en-US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 rot="18188627">
                <a:off x="2884344" y="4303881"/>
                <a:ext cx="9392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 </a:t>
                </a:r>
                <a:r>
                  <a:rPr lang="en-US" dirty="0" err="1" smtClean="0"/>
                  <a:t>si</a:t>
                </a:r>
                <a:endParaRPr lang="en-US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8188627">
                <a:off x="3143343" y="4314180"/>
                <a:ext cx="9392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err="1" smtClean="0"/>
                  <a:t>CTRLsi</a:t>
                </a:r>
                <a:endParaRPr lang="en-US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8188627">
                <a:off x="3498300" y="4334357"/>
                <a:ext cx="9392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 </a:t>
                </a:r>
                <a:r>
                  <a:rPr lang="en-US" dirty="0" err="1" smtClean="0"/>
                  <a:t>si</a:t>
                </a:r>
                <a:endParaRPr lang="en-US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2632572" y="4061344"/>
                <a:ext cx="24535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OVCAR-4  OVCAR4-PR2</a:t>
                </a:r>
                <a:endParaRPr lang="en-US" sz="1200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5358786" y="4923817"/>
                <a:ext cx="1469070" cy="3779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vinculin</a:t>
                </a:r>
                <a:endParaRPr lang="en-US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5427413" y="5624733"/>
                <a:ext cx="932488" cy="3697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</a:t>
                </a:r>
                <a:endParaRPr lang="en-US" dirty="0"/>
              </a:p>
            </p:txBody>
          </p:sp>
        </p:grpSp>
        <p:sp>
          <p:nvSpPr>
            <p:cNvPr id="53" name="TextBox 52"/>
            <p:cNvSpPr txBox="1"/>
            <p:nvPr/>
          </p:nvSpPr>
          <p:spPr>
            <a:xfrm>
              <a:off x="4723039" y="5302014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7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6988922" y="427504"/>
            <a:ext cx="4035418" cy="3209444"/>
            <a:chOff x="6988922" y="427504"/>
            <a:chExt cx="4035418" cy="3209444"/>
          </a:xfrm>
        </p:grpSpPr>
        <p:grpSp>
          <p:nvGrpSpPr>
            <p:cNvPr id="33" name="Group 32"/>
            <p:cNvGrpSpPr/>
            <p:nvPr/>
          </p:nvGrpSpPr>
          <p:grpSpPr>
            <a:xfrm>
              <a:off x="6988922" y="427504"/>
              <a:ext cx="4035418" cy="3209444"/>
              <a:chOff x="5587553" y="1424353"/>
              <a:chExt cx="4035418" cy="3209444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5587553" y="2130083"/>
                <a:ext cx="2307772" cy="2503714"/>
                <a:chOff x="4241074" y="809897"/>
                <a:chExt cx="2307772" cy="2503714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59000" contrast="1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504" t="36888" r="30444" b="50671"/>
                <a:stretch/>
              </p:blipFill>
              <p:spPr>
                <a:xfrm>
                  <a:off x="4241074" y="809897"/>
                  <a:ext cx="2307772" cy="809897"/>
                </a:xfrm>
                <a:prstGeom prst="rect">
                  <a:avLst/>
                </a:prstGeom>
              </p:spPr>
            </p:pic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47000" contrast="22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132" t="45867" r="31499" b="24866"/>
                <a:stretch/>
              </p:blipFill>
              <p:spPr>
                <a:xfrm>
                  <a:off x="4241074" y="1728651"/>
                  <a:ext cx="2307772" cy="1584960"/>
                </a:xfrm>
                <a:prstGeom prst="rect">
                  <a:avLst/>
                </a:prstGeom>
              </p:spPr>
            </p:pic>
            <p:sp>
              <p:nvSpPr>
                <p:cNvPr id="10" name="Rectangle 9"/>
                <p:cNvSpPr/>
                <p:nvPr/>
              </p:nvSpPr>
              <p:spPr>
                <a:xfrm>
                  <a:off x="5757706" y="1989574"/>
                  <a:ext cx="683288" cy="1215850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" name="Rectangle 10"/>
                <p:cNvSpPr/>
                <p:nvPr/>
              </p:nvSpPr>
              <p:spPr>
                <a:xfrm>
                  <a:off x="5717514" y="1004834"/>
                  <a:ext cx="683288" cy="251209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25" name="TextBox 24"/>
              <p:cNvSpPr txBox="1"/>
              <p:nvPr/>
            </p:nvSpPr>
            <p:spPr>
              <a:xfrm>
                <a:off x="7053943" y="1793685"/>
                <a:ext cx="256902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0    6.7  µM TRx0237</a:t>
                </a:r>
                <a:endParaRPr lang="en-US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7011048" y="1424353"/>
                <a:ext cx="157826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OVCAR4-PR2</a:t>
                </a:r>
                <a:endParaRPr lang="en-US" dirty="0"/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7902695" y="2275700"/>
                <a:ext cx="1469070" cy="3779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vinculin</a:t>
                </a:r>
                <a:endParaRPr lang="en-US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7940207" y="3387134"/>
                <a:ext cx="932488" cy="3697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tau</a:t>
                </a:r>
                <a:endParaRPr lang="en-US" dirty="0"/>
              </a:p>
            </p:txBody>
          </p:sp>
        </p:grpSp>
        <p:sp>
          <p:nvSpPr>
            <p:cNvPr id="52" name="TextBox 51"/>
            <p:cNvSpPr txBox="1"/>
            <p:nvPr/>
          </p:nvSpPr>
          <p:spPr>
            <a:xfrm>
              <a:off x="7171010" y="1480466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0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7308824" y="2412129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7308825" y="2611762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4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7300392" y="2968167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3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7300392" y="3180548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162058" y="1097688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313451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9668" y="176590"/>
            <a:ext cx="2002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6</a:t>
            </a:r>
            <a:endParaRPr lang="en-US" dirty="0"/>
          </a:p>
        </p:txBody>
      </p:sp>
      <p:grpSp>
        <p:nvGrpSpPr>
          <p:cNvPr id="25" name="Group 24"/>
          <p:cNvGrpSpPr/>
          <p:nvPr/>
        </p:nvGrpSpPr>
        <p:grpSpPr>
          <a:xfrm>
            <a:off x="1244354" y="-50912"/>
            <a:ext cx="5462331" cy="3250895"/>
            <a:chOff x="383381" y="575852"/>
            <a:chExt cx="5462331" cy="3250895"/>
          </a:xfrm>
        </p:grpSpPr>
        <p:grpSp>
          <p:nvGrpSpPr>
            <p:cNvPr id="9" name="Group 8"/>
            <p:cNvGrpSpPr/>
            <p:nvPr/>
          </p:nvGrpSpPr>
          <p:grpSpPr>
            <a:xfrm>
              <a:off x="383381" y="2058907"/>
              <a:ext cx="3831771" cy="1767840"/>
              <a:chOff x="496389" y="465908"/>
              <a:chExt cx="3831771" cy="1767840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681" t="36389" r="24218" b="4124"/>
              <a:stretch/>
            </p:blipFill>
            <p:spPr>
              <a:xfrm>
                <a:off x="496389" y="465908"/>
                <a:ext cx="3831771" cy="1767840"/>
              </a:xfrm>
              <a:prstGeom prst="rect">
                <a:avLst/>
              </a:prstGeom>
            </p:spPr>
          </p:pic>
          <p:sp>
            <p:nvSpPr>
              <p:cNvPr id="6" name="Rectangle 5"/>
              <p:cNvSpPr/>
              <p:nvPr/>
            </p:nvSpPr>
            <p:spPr>
              <a:xfrm>
                <a:off x="2682910" y="633045"/>
                <a:ext cx="1507253" cy="522514"/>
              </a:xfrm>
              <a:prstGeom prst="rect">
                <a:avLst/>
              </a:prstGeom>
              <a:noFill/>
              <a:ln>
                <a:solidFill>
                  <a:srgbClr val="FFFF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 rot="18462684">
              <a:off x="1103458" y="1216513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-4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8462684">
              <a:off x="1811626" y="1210425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4-PR2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8462684">
              <a:off x="2492467" y="1238278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-4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 rot="18462684">
              <a:off x="3200635" y="1232190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4-PR2</a:t>
              </a:r>
              <a:endParaRPr lang="en-US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252247" y="2302635"/>
              <a:ext cx="159346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ALDH1A1</a:t>
              </a:r>
              <a:endParaRPr lang="en-US" dirty="0"/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6420163" y="29033"/>
            <a:ext cx="4963884" cy="3220419"/>
            <a:chOff x="6000207" y="554077"/>
            <a:chExt cx="4963884" cy="3220419"/>
          </a:xfrm>
        </p:grpSpPr>
        <p:grpSp>
          <p:nvGrpSpPr>
            <p:cNvPr id="10" name="Group 9"/>
            <p:cNvGrpSpPr/>
            <p:nvPr/>
          </p:nvGrpSpPr>
          <p:grpSpPr>
            <a:xfrm>
              <a:off x="6000207" y="2058907"/>
              <a:ext cx="3884955" cy="1715589"/>
              <a:chOff x="496389" y="2619720"/>
              <a:chExt cx="3884955" cy="1715589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"/>
                        </a14:imgEffect>
                        <a14:imgEffect>
                          <a14:brightnessContrast bright="19000" contrast="2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922" t="19399" r="31538" b="19669"/>
              <a:stretch/>
            </p:blipFill>
            <p:spPr>
              <a:xfrm>
                <a:off x="496389" y="2619720"/>
                <a:ext cx="3884955" cy="1715589"/>
              </a:xfrm>
              <a:prstGeom prst="rect">
                <a:avLst/>
              </a:prstGeom>
            </p:spPr>
          </p:pic>
          <p:sp>
            <p:nvSpPr>
              <p:cNvPr id="7" name="Rectangle 6"/>
              <p:cNvSpPr/>
              <p:nvPr/>
            </p:nvSpPr>
            <p:spPr>
              <a:xfrm>
                <a:off x="1175657" y="3171039"/>
                <a:ext cx="1507253" cy="612950"/>
              </a:xfrm>
              <a:prstGeom prst="rect">
                <a:avLst/>
              </a:prstGeom>
              <a:noFill/>
              <a:ln>
                <a:solidFill>
                  <a:srgbClr val="FFFF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 rot="18462684">
              <a:off x="6733563" y="1194738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-4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 rot="18462684">
              <a:off x="7441731" y="1188650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4-PR2</a:t>
              </a:r>
              <a:endParaRPr lang="en-US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8462684">
              <a:off x="8122572" y="1216503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-4</a:t>
              </a:r>
              <a:endParaRPr lang="en-US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8462684">
              <a:off x="8830740" y="1210415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4-PR2</a:t>
              </a:r>
              <a:endParaRPr lang="en-US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953897" y="2732035"/>
              <a:ext cx="10101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D44</a:t>
              </a:r>
              <a:endParaRPr lang="en-US" dirty="0"/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3987553" y="3185283"/>
            <a:ext cx="5214723" cy="3433055"/>
            <a:chOff x="797710" y="3793679"/>
            <a:chExt cx="5214723" cy="3433055"/>
          </a:xfrm>
        </p:grpSpPr>
        <p:grpSp>
          <p:nvGrpSpPr>
            <p:cNvPr id="11" name="Group 10"/>
            <p:cNvGrpSpPr/>
            <p:nvPr/>
          </p:nvGrpSpPr>
          <p:grpSpPr>
            <a:xfrm>
              <a:off x="797710" y="5245534"/>
              <a:ext cx="3666309" cy="1981200"/>
              <a:chOff x="715035" y="4651612"/>
              <a:chExt cx="3666309" cy="1981200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8000"/>
                        </a14:imgEffect>
                        <a14:imgEffect>
                          <a14:brightnessContrast contrast="2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154" t="28648" r="28704" b="11454"/>
              <a:stretch/>
            </p:blipFill>
            <p:spPr>
              <a:xfrm>
                <a:off x="715035" y="4651612"/>
                <a:ext cx="3666309" cy="1981200"/>
              </a:xfrm>
              <a:prstGeom prst="rect">
                <a:avLst/>
              </a:prstGeom>
            </p:spPr>
          </p:pic>
          <p:sp>
            <p:nvSpPr>
              <p:cNvPr id="8" name="Rectangle 7"/>
              <p:cNvSpPr/>
              <p:nvPr/>
            </p:nvSpPr>
            <p:spPr>
              <a:xfrm>
                <a:off x="2796718" y="5584315"/>
                <a:ext cx="1507253" cy="223632"/>
              </a:xfrm>
              <a:prstGeom prst="rect">
                <a:avLst/>
              </a:prstGeom>
              <a:noFill/>
              <a:ln>
                <a:solidFill>
                  <a:srgbClr val="FFFF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0" name="TextBox 19"/>
            <p:cNvSpPr txBox="1"/>
            <p:nvPr/>
          </p:nvSpPr>
          <p:spPr>
            <a:xfrm rot="18462684">
              <a:off x="1456157" y="4434340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-4</a:t>
              </a:r>
              <a:endParaRPr lang="en-US" dirty="0"/>
            </a:p>
          </p:txBody>
        </p:sp>
        <p:sp>
          <p:nvSpPr>
            <p:cNvPr id="21" name="TextBox 20"/>
            <p:cNvSpPr txBox="1"/>
            <p:nvPr/>
          </p:nvSpPr>
          <p:spPr>
            <a:xfrm rot="18462684">
              <a:off x="2164325" y="4428252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4-PR2</a:t>
              </a:r>
              <a:endParaRPr lang="en-US" dirty="0"/>
            </a:p>
          </p:txBody>
        </p:sp>
        <p:sp>
          <p:nvSpPr>
            <p:cNvPr id="22" name="TextBox 21"/>
            <p:cNvSpPr txBox="1"/>
            <p:nvPr/>
          </p:nvSpPr>
          <p:spPr>
            <a:xfrm rot="18462684">
              <a:off x="2845166" y="4456105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-4</a:t>
              </a:r>
              <a:endParaRPr lang="en-US" dirty="0"/>
            </a:p>
          </p:txBody>
        </p:sp>
        <p:sp>
          <p:nvSpPr>
            <p:cNvPr id="23" name="TextBox 22"/>
            <p:cNvSpPr txBox="1"/>
            <p:nvPr/>
          </p:nvSpPr>
          <p:spPr>
            <a:xfrm rot="18462684">
              <a:off x="3553334" y="4450017"/>
              <a:ext cx="16384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VCAR4-PR2</a:t>
              </a:r>
              <a:endParaRPr lang="en-US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623424" y="6069874"/>
              <a:ext cx="13890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GAPDH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8148619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543522" y="233413"/>
            <a:ext cx="1915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7</a:t>
            </a:r>
            <a:endParaRPr lang="en-US" dirty="0"/>
          </a:p>
        </p:txBody>
      </p:sp>
      <p:grpSp>
        <p:nvGrpSpPr>
          <p:cNvPr id="66" name="Group 65"/>
          <p:cNvGrpSpPr/>
          <p:nvPr/>
        </p:nvGrpSpPr>
        <p:grpSpPr>
          <a:xfrm>
            <a:off x="1282001" y="850190"/>
            <a:ext cx="3453762" cy="4698285"/>
            <a:chOff x="1282001" y="850190"/>
            <a:chExt cx="3453762" cy="4698285"/>
          </a:xfrm>
        </p:grpSpPr>
        <p:grpSp>
          <p:nvGrpSpPr>
            <p:cNvPr id="15" name="Group 14"/>
            <p:cNvGrpSpPr/>
            <p:nvPr/>
          </p:nvGrpSpPr>
          <p:grpSpPr>
            <a:xfrm>
              <a:off x="1319811" y="850190"/>
              <a:ext cx="3415952" cy="4698285"/>
              <a:chOff x="1375954" y="1264956"/>
              <a:chExt cx="3574722" cy="4230157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1375954" y="2751913"/>
                <a:ext cx="1759132" cy="2743200"/>
                <a:chOff x="1375954" y="609600"/>
                <a:chExt cx="1759132" cy="2743200"/>
              </a:xfrm>
            </p:grpSpPr>
            <p:pic>
              <p:nvPicPr>
                <p:cNvPr id="22" name="Picture 21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-23000" contrast="-39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905" t="31738" r="37477" b="23206"/>
                <a:stretch/>
              </p:blipFill>
              <p:spPr>
                <a:xfrm>
                  <a:off x="1375954" y="609600"/>
                  <a:ext cx="1759132" cy="2743200"/>
                </a:xfrm>
                <a:prstGeom prst="rect">
                  <a:avLst/>
                </a:prstGeom>
              </p:spPr>
            </p:pic>
            <p:sp>
              <p:nvSpPr>
                <p:cNvPr id="2" name="Rectangle 1"/>
                <p:cNvSpPr/>
                <p:nvPr/>
              </p:nvSpPr>
              <p:spPr>
                <a:xfrm>
                  <a:off x="1385893" y="884255"/>
                  <a:ext cx="906733" cy="1235947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" name="Rectangle 6"/>
                <p:cNvSpPr/>
                <p:nvPr/>
              </p:nvSpPr>
              <p:spPr>
                <a:xfrm>
                  <a:off x="2333898" y="884254"/>
                  <a:ext cx="690912" cy="1235947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1689821" y="1264956"/>
                <a:ext cx="1728424" cy="1683502"/>
                <a:chOff x="1689821" y="1264956"/>
                <a:chExt cx="1728424" cy="1683502"/>
              </a:xfrm>
            </p:grpSpPr>
            <p:sp>
              <p:nvSpPr>
                <p:cNvPr id="10" name="TextBox 9"/>
                <p:cNvSpPr txBox="1"/>
                <p:nvPr/>
              </p:nvSpPr>
              <p:spPr>
                <a:xfrm rot="18447845">
                  <a:off x="1042818" y="1932124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Marker</a:t>
                  </a:r>
                  <a:endParaRPr lang="en-US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 rot="18447845">
                  <a:off x="1423851" y="1932123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OVCAR4-PR2</a:t>
                  </a:r>
                  <a:endParaRPr lang="en-US" dirty="0"/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 rot="18447845">
                  <a:off x="1764527" y="1932122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OVCAR-4</a:t>
                  </a:r>
                  <a:endParaRPr lang="en-US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 rot="18447845">
                  <a:off x="2046518" y="1927763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untreated</a:t>
                  </a:r>
                  <a:endParaRPr lang="en-US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 rot="18447845">
                  <a:off x="2401910" y="1911959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treated</a:t>
                  </a:r>
                  <a:endParaRPr lang="en-US" dirty="0"/>
                </a:p>
              </p:txBody>
            </p:sp>
          </p:grpSp>
          <p:sp>
            <p:nvSpPr>
              <p:cNvPr id="14" name="TextBox 13"/>
              <p:cNvSpPr txBox="1"/>
              <p:nvPr/>
            </p:nvSpPr>
            <p:spPr>
              <a:xfrm>
                <a:off x="3104808" y="3392013"/>
                <a:ext cx="184586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EGFR phY1086</a:t>
                </a:r>
                <a:endParaRPr lang="en-US" dirty="0"/>
              </a:p>
            </p:txBody>
          </p:sp>
        </p:grpSp>
        <p:sp>
          <p:nvSpPr>
            <p:cNvPr id="40" name="TextBox 39"/>
            <p:cNvSpPr txBox="1"/>
            <p:nvPr/>
          </p:nvSpPr>
          <p:spPr>
            <a:xfrm>
              <a:off x="1288962" y="3278536"/>
              <a:ext cx="354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0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329750" y="3678287"/>
              <a:ext cx="354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7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361549" y="4038391"/>
              <a:ext cx="354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361548" y="4353544"/>
              <a:ext cx="354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4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361547" y="4605926"/>
              <a:ext cx="354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3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373945" y="4788109"/>
              <a:ext cx="354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282001" y="2934286"/>
              <a:ext cx="354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288246" y="2596657"/>
              <a:ext cx="354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65" name="Group 64"/>
          <p:cNvGrpSpPr/>
          <p:nvPr/>
        </p:nvGrpSpPr>
        <p:grpSpPr>
          <a:xfrm>
            <a:off x="4974531" y="743031"/>
            <a:ext cx="3519376" cy="4288100"/>
            <a:chOff x="4974531" y="743031"/>
            <a:chExt cx="3519376" cy="4288100"/>
          </a:xfrm>
        </p:grpSpPr>
        <p:grpSp>
          <p:nvGrpSpPr>
            <p:cNvPr id="20" name="Group 19"/>
            <p:cNvGrpSpPr/>
            <p:nvPr/>
          </p:nvGrpSpPr>
          <p:grpSpPr>
            <a:xfrm>
              <a:off x="4974531" y="743031"/>
              <a:ext cx="3519376" cy="4288100"/>
              <a:chOff x="5892352" y="1324175"/>
              <a:chExt cx="3519376" cy="4288100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5892352" y="2869075"/>
                <a:ext cx="1724297" cy="2743200"/>
                <a:chOff x="3788229" y="609600"/>
                <a:chExt cx="1724297" cy="2743200"/>
              </a:xfrm>
            </p:grpSpPr>
            <p:pic>
              <p:nvPicPr>
                <p:cNvPr id="23" name="Picture 22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-1000" contrast="67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023" t="34426" r="40023" b="26061"/>
                <a:stretch/>
              </p:blipFill>
              <p:spPr>
                <a:xfrm>
                  <a:off x="3788229" y="609600"/>
                  <a:ext cx="1724297" cy="2743200"/>
                </a:xfrm>
                <a:prstGeom prst="rect">
                  <a:avLst/>
                </a:prstGeom>
              </p:spPr>
            </p:pic>
            <p:sp>
              <p:nvSpPr>
                <p:cNvPr id="8" name="Rectangle 7"/>
                <p:cNvSpPr/>
                <p:nvPr/>
              </p:nvSpPr>
              <p:spPr>
                <a:xfrm>
                  <a:off x="3946877" y="619780"/>
                  <a:ext cx="823906" cy="993673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" name="Rectangle 8"/>
                <p:cNvSpPr/>
                <p:nvPr/>
              </p:nvSpPr>
              <p:spPr>
                <a:xfrm>
                  <a:off x="4808268" y="619780"/>
                  <a:ext cx="615658" cy="993673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25" name="Group 24"/>
              <p:cNvGrpSpPr/>
              <p:nvPr/>
            </p:nvGrpSpPr>
            <p:grpSpPr>
              <a:xfrm>
                <a:off x="6356008" y="1324175"/>
                <a:ext cx="1673295" cy="1683502"/>
                <a:chOff x="1689821" y="1264956"/>
                <a:chExt cx="1728424" cy="1683502"/>
              </a:xfrm>
            </p:grpSpPr>
            <p:sp>
              <p:nvSpPr>
                <p:cNvPr id="26" name="TextBox 25"/>
                <p:cNvSpPr txBox="1"/>
                <p:nvPr/>
              </p:nvSpPr>
              <p:spPr>
                <a:xfrm rot="18447845">
                  <a:off x="1042818" y="1932124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Marker</a:t>
                  </a:r>
                  <a:endParaRPr lang="en-US" dirty="0"/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 rot="18447845">
                  <a:off x="1423851" y="1932123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OVCAR4-PR2</a:t>
                  </a:r>
                  <a:endParaRPr lang="en-US" dirty="0"/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 rot="18447845">
                  <a:off x="1764527" y="1932122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OVCAR-4</a:t>
                  </a:r>
                  <a:endParaRPr lang="en-US" dirty="0"/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 rot="18447845">
                  <a:off x="2046518" y="1927763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untreated</a:t>
                  </a:r>
                  <a:endParaRPr lang="en-US" dirty="0"/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 rot="18447845">
                  <a:off x="2401910" y="1911959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treated</a:t>
                  </a:r>
                  <a:endParaRPr lang="en-US" dirty="0"/>
                </a:p>
              </p:txBody>
            </p:sp>
          </p:grpSp>
          <p:sp>
            <p:nvSpPr>
              <p:cNvPr id="38" name="TextBox 37"/>
              <p:cNvSpPr txBox="1"/>
              <p:nvPr/>
            </p:nvSpPr>
            <p:spPr>
              <a:xfrm>
                <a:off x="7565860" y="3191425"/>
                <a:ext cx="184586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EGFR</a:t>
                </a:r>
                <a:endParaRPr lang="en-US" dirty="0"/>
              </a:p>
            </p:txBody>
          </p:sp>
        </p:grpSp>
        <p:sp>
          <p:nvSpPr>
            <p:cNvPr id="48" name="TextBox 47"/>
            <p:cNvSpPr txBox="1"/>
            <p:nvPr/>
          </p:nvSpPr>
          <p:spPr>
            <a:xfrm>
              <a:off x="5083580" y="3122052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0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105832" y="3607503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7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122619" y="4009283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152689" y="4320110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4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145227" y="4529578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3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133179" y="4713648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067662" y="2728221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086672" y="2390023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8046766" y="740347"/>
            <a:ext cx="3694566" cy="2937940"/>
            <a:chOff x="8046766" y="740347"/>
            <a:chExt cx="3694566" cy="2937940"/>
          </a:xfrm>
        </p:grpSpPr>
        <p:grpSp>
          <p:nvGrpSpPr>
            <p:cNvPr id="39" name="Group 38"/>
            <p:cNvGrpSpPr/>
            <p:nvPr/>
          </p:nvGrpSpPr>
          <p:grpSpPr>
            <a:xfrm>
              <a:off x="8046766" y="740347"/>
              <a:ext cx="3694566" cy="2937940"/>
              <a:chOff x="7034394" y="1197551"/>
              <a:chExt cx="3694566" cy="2937940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7034394" y="2733411"/>
                <a:ext cx="1733006" cy="1402080"/>
                <a:chOff x="6087292" y="609600"/>
                <a:chExt cx="1733006" cy="1402080"/>
              </a:xfrm>
            </p:grpSpPr>
            <p:pic>
              <p:nvPicPr>
                <p:cNvPr id="24" name="Picture 23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32000" contrast="21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495" t="30207" r="31544" b="20874"/>
                <a:stretch/>
              </p:blipFill>
              <p:spPr>
                <a:xfrm>
                  <a:off x="6087292" y="609600"/>
                  <a:ext cx="1733006" cy="1402080"/>
                </a:xfrm>
                <a:prstGeom prst="rect">
                  <a:avLst/>
                </a:prstGeom>
              </p:spPr>
            </p:pic>
            <p:sp>
              <p:nvSpPr>
                <p:cNvPr id="3" name="Rectangle 2"/>
                <p:cNvSpPr/>
                <p:nvPr/>
              </p:nvSpPr>
              <p:spPr>
                <a:xfrm>
                  <a:off x="6268278" y="808383"/>
                  <a:ext cx="824948" cy="424069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" name="Rectangle 10"/>
                <p:cNvSpPr/>
                <p:nvPr/>
              </p:nvSpPr>
              <p:spPr>
                <a:xfrm>
                  <a:off x="7116416" y="808383"/>
                  <a:ext cx="606287" cy="424069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  <a:prstDash val="dash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32" name="Group 31"/>
              <p:cNvGrpSpPr/>
              <p:nvPr/>
            </p:nvGrpSpPr>
            <p:grpSpPr>
              <a:xfrm>
                <a:off x="7525817" y="1197551"/>
                <a:ext cx="1589925" cy="1683502"/>
                <a:chOff x="1689821" y="1264956"/>
                <a:chExt cx="1728424" cy="1683502"/>
              </a:xfrm>
            </p:grpSpPr>
            <p:sp>
              <p:nvSpPr>
                <p:cNvPr id="33" name="TextBox 32"/>
                <p:cNvSpPr txBox="1"/>
                <p:nvPr/>
              </p:nvSpPr>
              <p:spPr>
                <a:xfrm rot="18447845">
                  <a:off x="1042818" y="1932124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Marker</a:t>
                  </a:r>
                  <a:endParaRPr lang="en-US" dirty="0"/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 rot="18447845">
                  <a:off x="1423851" y="1932123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OVCAR4-PR2</a:t>
                  </a:r>
                  <a:endParaRPr lang="en-US" dirty="0"/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 rot="18447845">
                  <a:off x="1764527" y="1932122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OVCAR-4</a:t>
                  </a:r>
                  <a:endParaRPr lang="en-US" dirty="0"/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 rot="18447845">
                  <a:off x="2046518" y="1927763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untreated</a:t>
                  </a:r>
                  <a:endParaRPr lang="en-US" dirty="0"/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 rot="18447845">
                  <a:off x="2401910" y="1911959"/>
                  <a:ext cx="166333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 smtClean="0"/>
                    <a:t>treated</a:t>
                  </a:r>
                  <a:endParaRPr lang="en-US" dirty="0"/>
                </a:p>
              </p:txBody>
            </p:sp>
          </p:grpSp>
          <p:sp>
            <p:nvSpPr>
              <p:cNvPr id="21" name="TextBox 20"/>
              <p:cNvSpPr txBox="1"/>
              <p:nvPr/>
            </p:nvSpPr>
            <p:spPr>
              <a:xfrm>
                <a:off x="8767400" y="2927317"/>
                <a:ext cx="19615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vinculin</a:t>
                </a:r>
                <a:endParaRPr lang="en-US" dirty="0"/>
              </a:p>
            </p:txBody>
          </p:sp>
        </p:grpSp>
        <p:sp>
          <p:nvSpPr>
            <p:cNvPr id="56" name="TextBox 55"/>
            <p:cNvSpPr txBox="1"/>
            <p:nvPr/>
          </p:nvSpPr>
          <p:spPr>
            <a:xfrm>
              <a:off x="8162614" y="2643488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0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8162615" y="2839445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7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8139515" y="3005634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8133894" y="3170814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4</a:t>
              </a:r>
              <a:r>
                <a:rPr lang="en-US" sz="800" dirty="0" smtClean="0">
                  <a:solidFill>
                    <a:schemeClr val="bg1"/>
                  </a:solidFill>
                </a:rPr>
                <a:t>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8143987" y="3327653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35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8161860" y="2470113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solidFill>
                    <a:schemeClr val="bg1"/>
                  </a:solidFill>
                </a:rPr>
                <a:t>1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8188861" y="2312119"/>
              <a:ext cx="3707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</a:rPr>
                <a:t>2</a:t>
              </a:r>
              <a:r>
                <a:rPr lang="en-US" sz="800" dirty="0" smtClean="0">
                  <a:solidFill>
                    <a:schemeClr val="bg1"/>
                  </a:solidFill>
                </a:rPr>
                <a:t>50</a:t>
              </a:r>
              <a:endParaRPr lang="en-US" sz="800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61450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196</Words>
  <Application>Microsoft Office PowerPoint</Application>
  <PresentationFormat>Widescreen</PresentationFormat>
  <Paragraphs>16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IC College of Pharmac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Barbolina, Maria</cp:lastModifiedBy>
  <cp:revision>25</cp:revision>
  <dcterms:created xsi:type="dcterms:W3CDTF">2022-07-12T21:49:42Z</dcterms:created>
  <dcterms:modified xsi:type="dcterms:W3CDTF">2022-09-06T14:18:49Z</dcterms:modified>
</cp:coreProperties>
</file>